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00"/>
    <p:restoredTop sz="94377" autoAdjust="0"/>
  </p:normalViewPr>
  <p:slideViewPr>
    <p:cSldViewPr snapToGrid="0">
      <p:cViewPr>
        <p:scale>
          <a:sx n="125" d="100"/>
          <a:sy n="125" d="100"/>
        </p:scale>
        <p:origin x="2010" y="-14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UÉ  DELGADO PERÓN" userId="84322152-c492-46c5-a02d-577d082b9e69" providerId="ADAL" clId="{EA45DF24-D974-4198-81F7-80108009DC90}"/>
    <pc:docChg chg="modSld">
      <pc:chgData name="JOSUÉ  DELGADO PERÓN" userId="84322152-c492-46c5-a02d-577d082b9e69" providerId="ADAL" clId="{EA45DF24-D974-4198-81F7-80108009DC90}" dt="2022-08-19T14:31:10.474" v="0" actId="20577"/>
      <pc:docMkLst>
        <pc:docMk/>
      </pc:docMkLst>
      <pc:sldChg chg="modSp mod">
        <pc:chgData name="JOSUÉ  DELGADO PERÓN" userId="84322152-c492-46c5-a02d-577d082b9e69" providerId="ADAL" clId="{EA45DF24-D974-4198-81F7-80108009DC90}" dt="2022-08-19T14:31:10.474" v="0" actId="20577"/>
        <pc:sldMkLst>
          <pc:docMk/>
          <pc:sldMk cId="2779746900" sldId="257"/>
        </pc:sldMkLst>
        <pc:spChg chg="mod">
          <ac:chgData name="JOSUÉ  DELGADO PERÓN" userId="84322152-c492-46c5-a02d-577d082b9e69" providerId="ADAL" clId="{EA45DF24-D974-4198-81F7-80108009DC90}" dt="2022-08-19T14:31:10.474" v="0" actId="20577"/>
          <ac:spMkLst>
            <pc:docMk/>
            <pc:sldMk cId="2779746900" sldId="257"/>
            <ac:spMk id="42" creationId="{77AB0F6D-06E8-81B5-B623-64FA53900FA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499"/>
            </a:lvl2pPr>
            <a:lvl3pPr marL="685742" indent="0" algn="ctr">
              <a:buNone/>
              <a:defRPr sz="1351"/>
            </a:lvl3pPr>
            <a:lvl4pPr marL="1028614" indent="0" algn="ctr">
              <a:buNone/>
              <a:defRPr sz="1200"/>
            </a:lvl4pPr>
            <a:lvl5pPr marL="1371485" indent="0" algn="ctr">
              <a:buNone/>
              <a:defRPr sz="1200"/>
            </a:lvl5pPr>
            <a:lvl6pPr marL="1714357" indent="0" algn="ctr">
              <a:buNone/>
              <a:defRPr sz="1200"/>
            </a:lvl6pPr>
            <a:lvl7pPr marL="2057227" indent="0" algn="ctr">
              <a:buNone/>
              <a:defRPr sz="1200"/>
            </a:lvl7pPr>
            <a:lvl8pPr marL="2400099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29491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683400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053649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41535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42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341978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66870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16437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93312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661974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592296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72" indent="0">
              <a:buNone/>
              <a:defRPr sz="2100"/>
            </a:lvl2pPr>
            <a:lvl3pPr marL="685742" indent="0">
              <a:buNone/>
              <a:defRPr sz="1800"/>
            </a:lvl3pPr>
            <a:lvl4pPr marL="1028614" indent="0">
              <a:buNone/>
              <a:defRPr sz="1499"/>
            </a:lvl4pPr>
            <a:lvl5pPr marL="1371485" indent="0">
              <a:buNone/>
              <a:defRPr sz="1499"/>
            </a:lvl5pPr>
            <a:lvl6pPr marL="1714357" indent="0">
              <a:buNone/>
              <a:defRPr sz="1499"/>
            </a:lvl6pPr>
            <a:lvl7pPr marL="2057227" indent="0">
              <a:buNone/>
              <a:defRPr sz="1499"/>
            </a:lvl7pPr>
            <a:lvl8pPr marL="2400099" indent="0">
              <a:buNone/>
              <a:defRPr sz="1499"/>
            </a:lvl8pPr>
            <a:lvl9pPr marL="2742970" indent="0">
              <a:buNone/>
              <a:defRPr sz="1499"/>
            </a:lvl9pPr>
          </a:lstStyle>
          <a:p>
            <a:r>
              <a:rPr lang="es-ES" dirty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300834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40A4D-E640-40AF-8ABE-FF027951117B}" type="datetimeFigureOut">
              <a:rPr lang="es-ES" smtClean="0"/>
              <a:t>03/11/2022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5BC469-BA81-4042-8FC9-B6BF753DBCAE}" type="slidenum">
              <a:rPr lang="es-ES" smtClean="0"/>
              <a:t>‹#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655079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3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42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5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7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7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9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CuadroTexto 41">
            <a:extLst>
              <a:ext uri="{FF2B5EF4-FFF2-40B4-BE49-F238E27FC236}">
                <a16:creationId xmlns:a16="http://schemas.microsoft.com/office/drawing/2014/main" id="{77AB0F6D-06E8-81B5-B623-64FA53900FAA}"/>
              </a:ext>
            </a:extLst>
          </p:cNvPr>
          <p:cNvSpPr txBox="1"/>
          <p:nvPr/>
        </p:nvSpPr>
        <p:spPr>
          <a:xfrm>
            <a:off x="70516" y="325598"/>
            <a:ext cx="67169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ive gut microbial abundances at the species level.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1890D892-3C67-BD7B-BF41-E7ED97565A1C}"/>
              </a:ext>
            </a:extLst>
          </p:cNvPr>
          <p:cNvGrpSpPr/>
          <p:nvPr/>
        </p:nvGrpSpPr>
        <p:grpSpPr>
          <a:xfrm>
            <a:off x="548305" y="2184553"/>
            <a:ext cx="6033143" cy="3563216"/>
            <a:chOff x="601437" y="5515347"/>
            <a:chExt cx="6033143" cy="3563216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0C8E131F-A581-FA37-EB2B-F24C2CFED3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79570" y="5794661"/>
              <a:ext cx="4661177" cy="2943635"/>
            </a:xfrm>
            <a:prstGeom prst="rect">
              <a:avLst/>
            </a:prstGeom>
          </p:spPr>
        </p:pic>
        <p:sp>
          <p:nvSpPr>
            <p:cNvPr id="6" name="Rectangle 287">
              <a:extLst>
                <a:ext uri="{FF2B5EF4-FFF2-40B4-BE49-F238E27FC236}">
                  <a16:creationId xmlns:a16="http://schemas.microsoft.com/office/drawing/2014/main" id="{2C895F5B-9119-9867-AED1-A492386699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0186" y="6177995"/>
              <a:ext cx="1064394" cy="22826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Victivallis vadensi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Osillospira guilliermondii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Clostridium methylpentosum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Robinsoniella peoriensi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Hespellia porcina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Clostridium symbiosum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Barnesiella intestinihomini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Alistipes putredini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Alistipes finegoldii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Parabacteroides gordonii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Parabacteroides distasoni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Bacteroides uniformi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Bacteroides fragili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Bacteroides acidifaciens</a:t>
              </a:r>
            </a:p>
            <a:p>
              <a:pPr defTabSz="914362">
                <a:spcBef>
                  <a:spcPts val="500"/>
                </a:spcBef>
              </a:pPr>
              <a:r>
                <a:rPr lang="es-ES" altLang="es-ES" sz="600" i="1" dirty="0">
                  <a:solidFill>
                    <a:srgbClr val="000000"/>
                  </a:solidFill>
                </a:rPr>
                <a:t>Bifidobacterium pseudolongum</a:t>
              </a:r>
            </a:p>
          </p:txBody>
        </p:sp>
        <p:sp>
          <p:nvSpPr>
            <p:cNvPr id="7" name="Rectangle 287">
              <a:extLst>
                <a:ext uri="{FF2B5EF4-FFF2-40B4-BE49-F238E27FC236}">
                  <a16:creationId xmlns:a16="http://schemas.microsoft.com/office/drawing/2014/main" id="{CEC07851-2A1A-6269-6F24-41B4605DC1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3462" y="5515347"/>
              <a:ext cx="757782" cy="1538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/>
              <a:r>
                <a:rPr lang="es-ES" altLang="es-ES" sz="1000" b="1" dirty="0">
                  <a:solidFill>
                    <a:srgbClr val="000000"/>
                  </a:solidFill>
                </a:rPr>
                <a:t>SPECIES    </a:t>
              </a:r>
              <a:endParaRPr lang="es-ES" altLang="es-ES" sz="1000" dirty="0"/>
            </a:p>
          </p:txBody>
        </p:sp>
        <p:sp>
          <p:nvSpPr>
            <p:cNvPr id="9" name="Rectangle 288">
              <a:extLst>
                <a:ext uri="{FF2B5EF4-FFF2-40B4-BE49-F238E27FC236}">
                  <a16:creationId xmlns:a16="http://schemas.microsoft.com/office/drawing/2014/main" id="{18BA5209-AF81-D7C1-5F87-4127A04F92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8787" y="8974739"/>
              <a:ext cx="456934" cy="103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/>
              <a:r>
                <a:rPr lang="es-ES" altLang="es-ES" sz="800" b="1" dirty="0">
                  <a:solidFill>
                    <a:srgbClr val="000000"/>
                  </a:solidFill>
                </a:rPr>
                <a:t>L-Carnitine</a:t>
              </a:r>
              <a:endParaRPr lang="es-ES" altLang="es-ES" dirty="0"/>
            </a:p>
          </p:txBody>
        </p:sp>
        <p:sp>
          <p:nvSpPr>
            <p:cNvPr id="10" name="Abrir corchete 9">
              <a:extLst>
                <a:ext uri="{FF2B5EF4-FFF2-40B4-BE49-F238E27FC236}">
                  <a16:creationId xmlns:a16="http://schemas.microsoft.com/office/drawing/2014/main" id="{9989189F-BB2C-A8C8-C097-EDBBE4095E08}"/>
                </a:ext>
              </a:extLst>
            </p:cNvPr>
            <p:cNvSpPr/>
            <p:nvPr/>
          </p:nvSpPr>
          <p:spPr>
            <a:xfrm rot="5400000" flipH="1">
              <a:off x="4026129" y="7618756"/>
              <a:ext cx="46855" cy="2592000"/>
            </a:xfrm>
            <a:prstGeom prst="leftBracke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4" name="Rectangle 287">
              <a:extLst>
                <a:ext uri="{FF2B5EF4-FFF2-40B4-BE49-F238E27FC236}">
                  <a16:creationId xmlns:a16="http://schemas.microsoft.com/office/drawing/2014/main" id="{F46ECC90-F0C3-D5F2-BB7D-7740126A35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5286" y="8799062"/>
              <a:ext cx="470453" cy="103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/>
              <a:r>
                <a:rPr lang="es-ES" altLang="es-ES" sz="800" b="1" dirty="0">
                  <a:solidFill>
                    <a:srgbClr val="000000"/>
                  </a:solidFill>
                </a:rPr>
                <a:t>CARNITINE</a:t>
              </a:r>
              <a:endParaRPr lang="es-ES" altLang="es-ES" dirty="0"/>
            </a:p>
          </p:txBody>
        </p:sp>
        <p:sp>
          <p:nvSpPr>
            <p:cNvPr id="15" name="Rectangle 287">
              <a:extLst>
                <a:ext uri="{FF2B5EF4-FFF2-40B4-BE49-F238E27FC236}">
                  <a16:creationId xmlns:a16="http://schemas.microsoft.com/office/drawing/2014/main" id="{4E479B9D-6F28-D54F-530C-71ED185A40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5174" y="8800968"/>
              <a:ext cx="366359" cy="103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/>
              <a:r>
                <a:rPr lang="es-ES" altLang="es-ES" sz="800" b="1" dirty="0">
                  <a:solidFill>
                    <a:srgbClr val="000000"/>
                  </a:solidFill>
                </a:rPr>
                <a:t>SAVORY</a:t>
              </a:r>
              <a:endParaRPr lang="es-ES" altLang="es-ES" dirty="0"/>
            </a:p>
          </p:txBody>
        </p:sp>
        <p:sp>
          <p:nvSpPr>
            <p:cNvPr id="16" name="Rectangle 287">
              <a:extLst>
                <a:ext uri="{FF2B5EF4-FFF2-40B4-BE49-F238E27FC236}">
                  <a16:creationId xmlns:a16="http://schemas.microsoft.com/office/drawing/2014/main" id="{17820E42-B91B-2330-DE4A-9865ED722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370" y="8800172"/>
              <a:ext cx="409618" cy="103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/>
              <a:r>
                <a:rPr lang="es-ES" altLang="es-ES" sz="800" b="1" dirty="0">
                  <a:solidFill>
                    <a:srgbClr val="000000"/>
                  </a:solidFill>
                </a:rPr>
                <a:t>PARSLEY</a:t>
              </a:r>
              <a:endParaRPr lang="es-ES" altLang="es-ES" dirty="0"/>
            </a:p>
          </p:txBody>
        </p:sp>
        <p:sp>
          <p:nvSpPr>
            <p:cNvPr id="17" name="Rectangle 287">
              <a:extLst>
                <a:ext uri="{FF2B5EF4-FFF2-40B4-BE49-F238E27FC236}">
                  <a16:creationId xmlns:a16="http://schemas.microsoft.com/office/drawing/2014/main" id="{68C10077-01CB-8E0B-64A8-D8B52AC7D1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7101" y="8797458"/>
              <a:ext cx="500194" cy="103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/>
              <a:r>
                <a:rPr lang="es-ES" altLang="es-ES" sz="800" b="1" dirty="0">
                  <a:solidFill>
                    <a:srgbClr val="000000"/>
                  </a:solidFill>
                </a:rPr>
                <a:t>ROSEMARY</a:t>
              </a:r>
              <a:endParaRPr lang="es-ES" altLang="es-ES" dirty="0"/>
            </a:p>
          </p:txBody>
        </p:sp>
        <p:sp>
          <p:nvSpPr>
            <p:cNvPr id="18" name="Rectangle 287">
              <a:extLst>
                <a:ext uri="{FF2B5EF4-FFF2-40B4-BE49-F238E27FC236}">
                  <a16:creationId xmlns:a16="http://schemas.microsoft.com/office/drawing/2014/main" id="{2C6549C8-6848-5184-A6EA-14BEF9F985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124" y="8799062"/>
              <a:ext cx="506549" cy="1231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362"/>
              <a:r>
                <a:rPr lang="es-ES" altLang="es-ES" sz="800" b="1" dirty="0">
                  <a:solidFill>
                    <a:srgbClr val="000000"/>
                  </a:solidFill>
                </a:rPr>
                <a:t>CONTROL</a:t>
              </a:r>
              <a:endParaRPr lang="es-ES" altLang="es-ES" dirty="0"/>
            </a:p>
          </p:txBody>
        </p:sp>
        <p:sp>
          <p:nvSpPr>
            <p:cNvPr id="19" name="Rectangle 287">
              <a:extLst>
                <a:ext uri="{FF2B5EF4-FFF2-40B4-BE49-F238E27FC236}">
                  <a16:creationId xmlns:a16="http://schemas.microsoft.com/office/drawing/2014/main" id="{71E03CEC-745E-5A4E-E058-091388E2CC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437" y="5759316"/>
              <a:ext cx="264495" cy="3021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10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9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8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7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6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5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4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3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2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10%</a:t>
              </a:r>
            </a:p>
            <a:p>
              <a:pPr algn="r" defTabSz="914362">
                <a:spcBef>
                  <a:spcPts val="1300"/>
                </a:spcBef>
              </a:pPr>
              <a:r>
                <a:rPr lang="es-ES" altLang="es-ES" sz="800" b="1" dirty="0">
                  <a:solidFill>
                    <a:srgbClr val="000000"/>
                  </a:solidFill>
                </a:rPr>
                <a:t>  0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797469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3</TotalTime>
  <Words>71</Words>
  <Application>Microsoft Office PowerPoint</Application>
  <PresentationFormat>A4 Paper (210x297 mm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 2</dc:creator>
  <cp:lastModifiedBy>MDPI</cp:lastModifiedBy>
  <cp:revision>25</cp:revision>
  <dcterms:created xsi:type="dcterms:W3CDTF">2022-03-07T10:46:13Z</dcterms:created>
  <dcterms:modified xsi:type="dcterms:W3CDTF">2022-11-03T13:27:32Z</dcterms:modified>
</cp:coreProperties>
</file>